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Default Extension="tiff" ContentType="image/tiff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3"/>
  </p:notesMasterIdLst>
  <p:sldIdLst>
    <p:sldId id="256" r:id="rId2"/>
    <p:sldId id="266" r:id="rId3"/>
    <p:sldId id="257" r:id="rId4"/>
    <p:sldId id="258" r:id="rId5"/>
    <p:sldId id="259" r:id="rId6"/>
    <p:sldId id="272" r:id="rId7"/>
    <p:sldId id="268" r:id="rId8"/>
    <p:sldId id="260" r:id="rId9"/>
    <p:sldId id="269" r:id="rId10"/>
    <p:sldId id="270" r:id="rId11"/>
    <p:sldId id="271" r:id="rId1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ampbell, Heather F" initials="CHF" lastIdx="1" clrIdx="0">
    <p:extLst>
      <p:ext uri="{19B8F6BF-5375-455C-9EA6-DF929625EA0E}">
        <p15:presenceInfo xmlns:p15="http://schemas.microsoft.com/office/powerpoint/2012/main" userId="S-1-5-21-1004336348-1409082233-839522115-5615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85000" autoAdjust="0"/>
  </p:normalViewPr>
  <p:slideViewPr>
    <p:cSldViewPr snapToGrid="0">
      <p:cViewPr varScale="1">
        <p:scale>
          <a:sx n="71" d="100"/>
          <a:sy n="71" d="100"/>
        </p:scale>
        <p:origin x="316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commentAuthors" Target="commentAuthor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3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2" Type="http://schemas.openxmlformats.org/officeDocument/2006/relationships/image" Target="../media/image15.emf"/><Relationship Id="rId1" Type="http://schemas.openxmlformats.org/officeDocument/2006/relationships/image" Target="../media/image14.emf"/><Relationship Id="rId5" Type="http://schemas.openxmlformats.org/officeDocument/2006/relationships/image" Target="../media/image18.emf"/><Relationship Id="rId4" Type="http://schemas.openxmlformats.org/officeDocument/2006/relationships/image" Target="../media/image17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9.emf"/></Relationships>
</file>

<file path=ppt/drawings/_rels/vmlDrawing4.vml.rels><?xml version="1.0" encoding="UTF-8" standalone="yes"?>
<Relationships xmlns="http://schemas.openxmlformats.org/package/2006/relationships"><Relationship Id="rId2" Type="http://schemas.openxmlformats.org/officeDocument/2006/relationships/image" Target="../media/image22.emf"/><Relationship Id="rId1" Type="http://schemas.openxmlformats.org/officeDocument/2006/relationships/image" Target="../media/image2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D84757F-3549-4700-957A-FB4E5B3B94DB}" type="datetimeFigureOut">
              <a:rPr lang="en-US" smtClean="0"/>
              <a:t>11/8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C028B3A-43CC-4ADD-B036-D360664BFA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30731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2E43F94-EC7D-48D1-81B7-E09F731DDD42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704738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2E43F94-EC7D-48D1-81B7-E09F731DDD42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79239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2E43F94-EC7D-48D1-81B7-E09F731DDD42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267437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2E43F94-EC7D-48D1-81B7-E09F731DDD42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844587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5E54422-5227-484D-A196-A393C711EBD9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9135425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5E54422-5227-484D-A196-A393C711EBD9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32640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0630BB-B0D5-406D-8E2A-D9C8F98734C6}" type="datetimeFigureOut">
              <a:rPr lang="en-US" smtClean="0"/>
              <a:t>11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5A0775-4417-4DBA-84DF-247D1B934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33850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0630BB-B0D5-406D-8E2A-D9C8F98734C6}" type="datetimeFigureOut">
              <a:rPr lang="en-US" smtClean="0"/>
              <a:t>11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5A0775-4417-4DBA-84DF-247D1B934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33461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0630BB-B0D5-406D-8E2A-D9C8F98734C6}" type="datetimeFigureOut">
              <a:rPr lang="en-US" smtClean="0"/>
              <a:t>11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5A0775-4417-4DBA-84DF-247D1B934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44016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0630BB-B0D5-406D-8E2A-D9C8F98734C6}" type="datetimeFigureOut">
              <a:rPr lang="en-US" smtClean="0"/>
              <a:t>11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5A0775-4417-4DBA-84DF-247D1B934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55154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0630BB-B0D5-406D-8E2A-D9C8F98734C6}" type="datetimeFigureOut">
              <a:rPr lang="en-US" smtClean="0"/>
              <a:t>11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5A0775-4417-4DBA-84DF-247D1B934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96180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0630BB-B0D5-406D-8E2A-D9C8F98734C6}" type="datetimeFigureOut">
              <a:rPr lang="en-US" smtClean="0"/>
              <a:t>11/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5A0775-4417-4DBA-84DF-247D1B934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99420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0630BB-B0D5-406D-8E2A-D9C8F98734C6}" type="datetimeFigureOut">
              <a:rPr lang="en-US" smtClean="0"/>
              <a:t>11/8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5A0775-4417-4DBA-84DF-247D1B934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47008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0630BB-B0D5-406D-8E2A-D9C8F98734C6}" type="datetimeFigureOut">
              <a:rPr lang="en-US" smtClean="0"/>
              <a:t>11/8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5A0775-4417-4DBA-84DF-247D1B934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4274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0630BB-B0D5-406D-8E2A-D9C8F98734C6}" type="datetimeFigureOut">
              <a:rPr lang="en-US" smtClean="0"/>
              <a:t>11/8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5A0775-4417-4DBA-84DF-247D1B934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59177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0630BB-B0D5-406D-8E2A-D9C8F98734C6}" type="datetimeFigureOut">
              <a:rPr lang="en-US" smtClean="0"/>
              <a:t>11/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5A0775-4417-4DBA-84DF-247D1B934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58632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0630BB-B0D5-406D-8E2A-D9C8F98734C6}" type="datetimeFigureOut">
              <a:rPr lang="en-US" smtClean="0"/>
              <a:t>11/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5A0775-4417-4DBA-84DF-247D1B934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66709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0630BB-B0D5-406D-8E2A-D9C8F98734C6}" type="datetimeFigureOut">
              <a:rPr lang="en-US" smtClean="0"/>
              <a:t>11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5A0775-4417-4DBA-84DF-247D1B934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51543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emf"/><Relationship Id="rId3" Type="http://schemas.openxmlformats.org/officeDocument/2006/relationships/notesSlide" Target="../notesSlides/notesSlide6.xml"/><Relationship Id="rId7" Type="http://schemas.openxmlformats.org/officeDocument/2006/relationships/oleObject" Target="../embeddings/oleObject9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21.emf"/><Relationship Id="rId5" Type="http://schemas.openxmlformats.org/officeDocument/2006/relationships/oleObject" Target="../embeddings/oleObject8.bin"/><Relationship Id="rId4" Type="http://schemas.openxmlformats.org/officeDocument/2006/relationships/image" Target="../media/image23.png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tiff"/><Relationship Id="rId5" Type="http://schemas.openxmlformats.org/officeDocument/2006/relationships/image" Target="../media/image5.tiff"/><Relationship Id="rId4" Type="http://schemas.openxmlformats.org/officeDocument/2006/relationships/image" Target="../media/image4.tif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tiff"/><Relationship Id="rId3" Type="http://schemas.openxmlformats.org/officeDocument/2006/relationships/image" Target="../media/image7.tiff"/><Relationship Id="rId7" Type="http://schemas.openxmlformats.org/officeDocument/2006/relationships/image" Target="../media/image11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tiff"/><Relationship Id="rId5" Type="http://schemas.openxmlformats.org/officeDocument/2006/relationships/image" Target="../media/image9.tiff"/><Relationship Id="rId4" Type="http://schemas.openxmlformats.org/officeDocument/2006/relationships/image" Target="../media/image8.tif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3.em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18.emf"/><Relationship Id="rId3" Type="http://schemas.openxmlformats.org/officeDocument/2006/relationships/notesSlide" Target="../notesSlides/notesSlide4.xml"/><Relationship Id="rId7" Type="http://schemas.openxmlformats.org/officeDocument/2006/relationships/image" Target="../media/image15.emf"/><Relationship Id="rId12" Type="http://schemas.openxmlformats.org/officeDocument/2006/relationships/oleObject" Target="../embeddings/oleObject6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17.emf"/><Relationship Id="rId5" Type="http://schemas.openxmlformats.org/officeDocument/2006/relationships/image" Target="../media/image14.emf"/><Relationship Id="rId10" Type="http://schemas.openxmlformats.org/officeDocument/2006/relationships/oleObject" Target="../embeddings/oleObject5.bin"/><Relationship Id="rId4" Type="http://schemas.openxmlformats.org/officeDocument/2006/relationships/oleObject" Target="../embeddings/oleObject2.bin"/><Relationship Id="rId9" Type="http://schemas.openxmlformats.org/officeDocument/2006/relationships/image" Target="../media/image16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5.xml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20.png"/><Relationship Id="rId5" Type="http://schemas.openxmlformats.org/officeDocument/2006/relationships/image" Target="../media/image19.emf"/><Relationship Id="rId4" Type="http://schemas.openxmlformats.org/officeDocument/2006/relationships/oleObject" Target="../embeddings/oleObject7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Supplemental Figure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3634525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84926" y="23219"/>
            <a:ext cx="3467849" cy="3340694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404299" y="0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A)</a:t>
            </a:r>
          </a:p>
        </p:txBody>
      </p:sp>
      <p:grpSp>
        <p:nvGrpSpPr>
          <p:cNvPr id="12" name="Group 11"/>
          <p:cNvGrpSpPr/>
          <p:nvPr/>
        </p:nvGrpSpPr>
        <p:grpSpPr>
          <a:xfrm>
            <a:off x="705927" y="3084051"/>
            <a:ext cx="5475574" cy="2766026"/>
            <a:chOff x="564776" y="311804"/>
            <a:chExt cx="10942100" cy="5090268"/>
          </a:xfrm>
        </p:grpSpPr>
        <p:graphicFrame>
          <p:nvGraphicFramePr>
            <p:cNvPr id="4" name="Object 3"/>
            <p:cNvGraphicFramePr>
              <a:graphicFrameLocks noChangeAspect="1"/>
            </p:cNvGraphicFramePr>
            <p:nvPr/>
          </p:nvGraphicFramePr>
          <p:xfrm>
            <a:off x="564776" y="311804"/>
            <a:ext cx="10942100" cy="509026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7198" name="Prism 7" r:id="rId5" imgW="5268786" imgH="2451569" progId="Prism7.Document">
                    <p:embed/>
                  </p:oleObj>
                </mc:Choice>
                <mc:Fallback>
                  <p:oleObj name="Prism 7" r:id="rId5" imgW="5268786" imgH="2451569" progId="Prism7.Document">
                    <p:embed/>
                    <p:pic>
                      <p:nvPicPr>
                        <p:cNvPr id="4" name="Object 3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564776" y="311804"/>
                          <a:ext cx="10942100" cy="509026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" name="Oval 6"/>
            <p:cNvSpPr/>
            <p:nvPr/>
          </p:nvSpPr>
          <p:spPr>
            <a:xfrm rot="21242112">
              <a:off x="3318896" y="3103740"/>
              <a:ext cx="1331428" cy="838993"/>
            </a:xfrm>
            <a:prstGeom prst="ellipse">
              <a:avLst/>
            </a:prstGeom>
            <a:noFill/>
            <a:ln w="381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013"/>
            </a:p>
          </p:txBody>
        </p:sp>
        <p:sp>
          <p:nvSpPr>
            <p:cNvPr id="8" name="Oval 7"/>
            <p:cNvSpPr/>
            <p:nvPr/>
          </p:nvSpPr>
          <p:spPr>
            <a:xfrm rot="5400000">
              <a:off x="2544941" y="1260315"/>
              <a:ext cx="984738" cy="839043"/>
            </a:xfrm>
            <a:prstGeom prst="ellipse">
              <a:avLst/>
            </a:prstGeom>
            <a:noFill/>
            <a:ln w="38100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013"/>
            </a:p>
          </p:txBody>
        </p:sp>
        <p:sp>
          <p:nvSpPr>
            <p:cNvPr id="9" name="Oval 8"/>
            <p:cNvSpPr/>
            <p:nvPr/>
          </p:nvSpPr>
          <p:spPr>
            <a:xfrm rot="2774356">
              <a:off x="1758924" y="3381787"/>
              <a:ext cx="840729" cy="1570891"/>
            </a:xfrm>
            <a:prstGeom prst="ellipse">
              <a:avLst/>
            </a:prstGeom>
            <a:noFill/>
            <a:ln w="38100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013"/>
            </a:p>
          </p:txBody>
        </p:sp>
        <p:sp>
          <p:nvSpPr>
            <p:cNvPr id="10" name="Oval 9"/>
            <p:cNvSpPr/>
            <p:nvPr/>
          </p:nvSpPr>
          <p:spPr>
            <a:xfrm rot="3811072">
              <a:off x="4686954" y="2913323"/>
              <a:ext cx="885198" cy="1875776"/>
            </a:xfrm>
            <a:prstGeom prst="ellipse">
              <a:avLst/>
            </a:prstGeom>
            <a:noFill/>
            <a:ln w="381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013"/>
            </a:p>
          </p:txBody>
        </p:sp>
      </p:grpSp>
      <p:sp>
        <p:nvSpPr>
          <p:cNvPr id="13" name="TextBox 12"/>
          <p:cNvSpPr txBox="1"/>
          <p:nvPr/>
        </p:nvSpPr>
        <p:spPr>
          <a:xfrm>
            <a:off x="348644" y="3084051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B)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226827" y="5903641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C)</a:t>
            </a:r>
          </a:p>
        </p:txBody>
      </p:sp>
      <p:graphicFrame>
        <p:nvGraphicFramePr>
          <p:cNvPr id="19" name="Object 18"/>
          <p:cNvGraphicFramePr>
            <a:graphicFrameLocks noChangeAspect="1"/>
          </p:cNvGraphicFramePr>
          <p:nvPr/>
        </p:nvGraphicFramePr>
        <p:xfrm>
          <a:off x="128128" y="5948359"/>
          <a:ext cx="6631174" cy="287874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99" name="Prism 7" r:id="rId7" imgW="5964208" imgH="2588787" progId="Prism7.Document">
                  <p:embed/>
                </p:oleObj>
              </mc:Choice>
              <mc:Fallback>
                <p:oleObj name="Prism 7" r:id="rId7" imgW="5964208" imgH="2588787" progId="Prism7.Document">
                  <p:embed/>
                  <p:pic>
                    <p:nvPicPr>
                      <p:cNvPr id="19" name="Object 18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28128" y="5948359"/>
                        <a:ext cx="6631174" cy="287874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" name="Oval 19"/>
          <p:cNvSpPr/>
          <p:nvPr/>
        </p:nvSpPr>
        <p:spPr>
          <a:xfrm rot="2662009">
            <a:off x="2073317" y="6496835"/>
            <a:ext cx="297416" cy="1209216"/>
          </a:xfrm>
          <a:prstGeom prst="ellipse">
            <a:avLst/>
          </a:prstGeom>
          <a:noFill/>
          <a:ln w="3810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sp>
        <p:nvSpPr>
          <p:cNvPr id="21" name="Oval 20"/>
          <p:cNvSpPr/>
          <p:nvPr/>
        </p:nvSpPr>
        <p:spPr>
          <a:xfrm rot="2662009">
            <a:off x="1664923" y="6572065"/>
            <a:ext cx="385075" cy="756065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sp>
        <p:nvSpPr>
          <p:cNvPr id="22" name="Oval 21"/>
          <p:cNvSpPr/>
          <p:nvPr/>
        </p:nvSpPr>
        <p:spPr>
          <a:xfrm rot="2662009">
            <a:off x="1985184" y="7612555"/>
            <a:ext cx="385075" cy="362886"/>
          </a:xfrm>
          <a:prstGeom prst="ellipse">
            <a:avLst/>
          </a:prstGeom>
          <a:noFill/>
          <a:ln w="38100"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sp>
        <p:nvSpPr>
          <p:cNvPr id="23" name="Oval 22"/>
          <p:cNvSpPr/>
          <p:nvPr/>
        </p:nvSpPr>
        <p:spPr>
          <a:xfrm rot="1844812">
            <a:off x="2515926" y="7833325"/>
            <a:ext cx="736924" cy="392181"/>
          </a:xfrm>
          <a:prstGeom prst="ellipse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sp>
        <p:nvSpPr>
          <p:cNvPr id="24" name="Oval 23"/>
          <p:cNvSpPr/>
          <p:nvPr/>
        </p:nvSpPr>
        <p:spPr>
          <a:xfrm rot="742297">
            <a:off x="804733" y="7659801"/>
            <a:ext cx="522694" cy="142294"/>
          </a:xfrm>
          <a:prstGeom prst="ellipse">
            <a:avLst/>
          </a:prstGeom>
          <a:noFill/>
          <a:ln w="38100"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sp>
        <p:nvSpPr>
          <p:cNvPr id="25" name="Oval 24"/>
          <p:cNvSpPr/>
          <p:nvPr/>
        </p:nvSpPr>
        <p:spPr>
          <a:xfrm rot="742297">
            <a:off x="909945" y="7707153"/>
            <a:ext cx="251399" cy="207691"/>
          </a:xfrm>
          <a:prstGeom prst="ellipse">
            <a:avLst/>
          </a:prstGeom>
          <a:noFill/>
          <a:ln w="381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sp>
        <p:nvSpPr>
          <p:cNvPr id="26" name="Rectangle 25"/>
          <p:cNvSpPr/>
          <p:nvPr/>
        </p:nvSpPr>
        <p:spPr>
          <a:xfrm>
            <a:off x="-1112" y="-62258"/>
            <a:ext cx="142038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 smtClean="0">
                <a:latin typeface="+mj-lt"/>
              </a:rPr>
              <a:t>Supp</a:t>
            </a:r>
            <a:r>
              <a:rPr lang="en-US" b="1" dirty="0" smtClean="0">
                <a:latin typeface="+mj-lt"/>
              </a:rPr>
              <a:t> Figure 8</a:t>
            </a:r>
            <a:endParaRPr lang="en-US" b="1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28046420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6986337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8. Mass spectrometry proteomic analysis of conditioned media samples from 3 </a:t>
            </a:r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BMAds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onors and myeloma cells grown on silk scaffolds alone and in co-culture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ially expressed proteins from experiments utilizing 3 donors (A) were compared via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eractiveVenn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interactivevenn.net). PCA analysis revealed differential protein expression between sample types (B) from 1 experiment using a single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BMAd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onor and a second experiment using two additional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BMAd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onors (C); n=3 scaffolds per group. 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156643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-1112" y="-62258"/>
            <a:ext cx="142038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 smtClean="0">
                <a:latin typeface="+mj-lt"/>
              </a:rPr>
              <a:t>Supp</a:t>
            </a:r>
            <a:r>
              <a:rPr lang="en-US" b="1" dirty="0" smtClean="0">
                <a:latin typeface="+mj-lt"/>
              </a:rPr>
              <a:t> Figure </a:t>
            </a:r>
            <a:r>
              <a:rPr lang="en-US" b="1" dirty="0">
                <a:latin typeface="+mj-lt"/>
              </a:rPr>
              <a:t>1</a:t>
            </a:r>
          </a:p>
        </p:txBody>
      </p:sp>
      <p:sp>
        <p:nvSpPr>
          <p:cNvPr id="3" name="Rectangle 2"/>
          <p:cNvSpPr/>
          <p:nvPr/>
        </p:nvSpPr>
        <p:spPr>
          <a:xfrm>
            <a:off x="-1112" y="2991768"/>
            <a:ext cx="6858000" cy="25853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defTabSz="914400">
              <a:defRPr/>
            </a:pP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 MSC-derived bone marrow adipocytes with </a:t>
            </a:r>
            <a:r>
              <a:rPr lang="en-US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ltilocular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lipid droplets.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one marrow stromal cells were isolated from patient bone marrow biopsies by tissue culture plastic adherence. Cells were differentiated for 21 days in 6-well plates as previously described (Fairfield et al. 2021 Can Res). Fully differentiated adipocytes present with </a:t>
            </a:r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ltilocular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lipid droplets (examples highlighted with orange arrows). Images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rated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sing EVOS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M5000 Digital Inverted Fluorescence and Transmitted Light Imaging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ystem under </a:t>
            </a:r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rightfield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10X objective. 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27322" y="440554"/>
            <a:ext cx="3223647" cy="2417735"/>
          </a:xfrm>
          <a:prstGeom prst="rect">
            <a:avLst/>
          </a:prstGeom>
        </p:spPr>
      </p:pic>
      <p:cxnSp>
        <p:nvCxnSpPr>
          <p:cNvPr id="6" name="Straight Arrow Connector 5"/>
          <p:cNvCxnSpPr/>
          <p:nvPr/>
        </p:nvCxnSpPr>
        <p:spPr>
          <a:xfrm flipV="1">
            <a:off x="3457575" y="1066800"/>
            <a:ext cx="276225" cy="180975"/>
          </a:xfrm>
          <a:prstGeom prst="straightConnector1">
            <a:avLst/>
          </a:prstGeom>
          <a:ln w="38100">
            <a:solidFill>
              <a:schemeClr val="accent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/>
          <p:cNvCxnSpPr/>
          <p:nvPr/>
        </p:nvCxnSpPr>
        <p:spPr>
          <a:xfrm flipV="1">
            <a:off x="3319462" y="2047875"/>
            <a:ext cx="276225" cy="180975"/>
          </a:xfrm>
          <a:prstGeom prst="straightConnector1">
            <a:avLst/>
          </a:prstGeom>
          <a:ln w="38100">
            <a:solidFill>
              <a:schemeClr val="accent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/>
          <p:cNvCxnSpPr/>
          <p:nvPr/>
        </p:nvCxnSpPr>
        <p:spPr>
          <a:xfrm flipV="1">
            <a:off x="2307068" y="1157287"/>
            <a:ext cx="276225" cy="180975"/>
          </a:xfrm>
          <a:prstGeom prst="straightConnector1">
            <a:avLst/>
          </a:prstGeom>
          <a:ln w="38100">
            <a:solidFill>
              <a:schemeClr val="accent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/>
          <p:cNvCxnSpPr/>
          <p:nvPr/>
        </p:nvCxnSpPr>
        <p:spPr>
          <a:xfrm flipV="1">
            <a:off x="3043237" y="2448319"/>
            <a:ext cx="276225" cy="180975"/>
          </a:xfrm>
          <a:prstGeom prst="straightConnector1">
            <a:avLst/>
          </a:prstGeom>
          <a:ln w="38100">
            <a:solidFill>
              <a:schemeClr val="accent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/>
          <p:cNvCxnSpPr/>
          <p:nvPr/>
        </p:nvCxnSpPr>
        <p:spPr>
          <a:xfrm flipV="1">
            <a:off x="2116205" y="2153241"/>
            <a:ext cx="276225" cy="180975"/>
          </a:xfrm>
          <a:prstGeom prst="straightConnector1">
            <a:avLst/>
          </a:prstGeom>
          <a:ln w="38100">
            <a:solidFill>
              <a:schemeClr val="accent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/>
          <p:cNvCxnSpPr/>
          <p:nvPr/>
        </p:nvCxnSpPr>
        <p:spPr>
          <a:xfrm flipV="1">
            <a:off x="2363855" y="2210391"/>
            <a:ext cx="276225" cy="180975"/>
          </a:xfrm>
          <a:prstGeom prst="straightConnector1">
            <a:avLst/>
          </a:prstGeom>
          <a:ln w="38100">
            <a:solidFill>
              <a:schemeClr val="accent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Rectangle 13"/>
          <p:cNvSpPr/>
          <p:nvPr/>
        </p:nvSpPr>
        <p:spPr>
          <a:xfrm>
            <a:off x="3943978" y="2605664"/>
            <a:ext cx="713433" cy="67198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extBox 12"/>
          <p:cNvSpPr txBox="1"/>
          <p:nvPr/>
        </p:nvSpPr>
        <p:spPr>
          <a:xfrm>
            <a:off x="3943978" y="2531365"/>
            <a:ext cx="723569" cy="1958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solidFill>
                  <a:schemeClr val="bg1"/>
                </a:solidFill>
              </a:rPr>
              <a:t>300 µm</a:t>
            </a:r>
            <a:endParaRPr lang="en-US" sz="80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522287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112" y="475725"/>
            <a:ext cx="6858000" cy="6858000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6374" y="495630"/>
            <a:ext cx="4640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(A)</a:t>
            </a:r>
            <a:endParaRPr lang="en-US" b="1" dirty="0">
              <a:solidFill>
                <a:schemeClr val="bg1"/>
              </a:solidFill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479372" y="495630"/>
            <a:ext cx="5581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(B)</a:t>
            </a:r>
            <a:endParaRPr lang="en-US" b="1" dirty="0">
              <a:solidFill>
                <a:schemeClr val="bg1"/>
              </a:solidFill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6374" y="3890939"/>
            <a:ext cx="6529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(C)</a:t>
            </a:r>
            <a:endParaRPr lang="en-US" b="1" dirty="0">
              <a:solidFill>
                <a:schemeClr val="bg1"/>
              </a:solidFill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479372" y="3890939"/>
            <a:ext cx="5850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(D)</a:t>
            </a:r>
            <a:endParaRPr lang="en-US" b="1" dirty="0">
              <a:solidFill>
                <a:schemeClr val="bg1"/>
              </a:solidFill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-1112" y="-62258"/>
            <a:ext cx="142038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 smtClean="0">
                <a:latin typeface="+mj-lt"/>
              </a:rPr>
              <a:t>Supp</a:t>
            </a:r>
            <a:r>
              <a:rPr lang="en-US" b="1" dirty="0" smtClean="0">
                <a:latin typeface="+mj-lt"/>
              </a:rPr>
              <a:t> Figure </a:t>
            </a:r>
            <a:r>
              <a:rPr lang="en-US" b="1" dirty="0">
                <a:latin typeface="+mj-lt"/>
              </a:rPr>
              <a:t>2</a:t>
            </a:r>
          </a:p>
        </p:txBody>
      </p:sp>
      <p:cxnSp>
        <p:nvCxnSpPr>
          <p:cNvPr id="7" name="Straight Connector 6"/>
          <p:cNvCxnSpPr/>
          <p:nvPr/>
        </p:nvCxnSpPr>
        <p:spPr>
          <a:xfrm>
            <a:off x="3404073" y="475725"/>
            <a:ext cx="0" cy="68580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>
            <a:stCxn id="16" idx="3"/>
            <a:endCxn id="16" idx="1"/>
          </p:cNvCxnSpPr>
          <p:nvPr/>
        </p:nvCxnSpPr>
        <p:spPr>
          <a:xfrm flipH="1">
            <a:off x="-1112" y="3904725"/>
            <a:ext cx="68580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Rectangle 1"/>
          <p:cNvSpPr/>
          <p:nvPr/>
        </p:nvSpPr>
        <p:spPr>
          <a:xfrm>
            <a:off x="46629" y="7112675"/>
            <a:ext cx="6865486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US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. </a:t>
            </a:r>
            <a:r>
              <a:rPr lang="en-US" b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BMAds</a:t>
            </a:r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ultured on scaffolds for 3 weeks imaged with confocal microscopy using maximum projection images.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A) Blue channel showing DAPI and silk scaffolds. (B) Green channel showing </a:t>
            </a:r>
            <a:r>
              <a:rPr lang="en-US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halloidin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/F-Actin (bright green), and silk scaffolds (dimmer green). (C) Red channel showing Oil red O staining of lipids. (D) Overlay of all </a:t>
            </a:r>
            <a:r>
              <a:rPr lang="en-US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hannels shows cells (green) on blue scaffolds. </a:t>
            </a:r>
            <a:endParaRPr lang="en-US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307861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517501" y="0"/>
            <a:ext cx="5915025" cy="664633"/>
          </a:xfrm>
        </p:spPr>
        <p:txBody>
          <a:bodyPr/>
          <a:lstStyle/>
          <a:p>
            <a:r>
              <a:rPr lang="en-US" dirty="0"/>
              <a:t>Donor R21-1054 </a:t>
            </a:r>
            <a:r>
              <a:rPr lang="en-US" dirty="0" err="1" smtClean="0"/>
              <a:t>pBMAds</a:t>
            </a:r>
            <a:r>
              <a:rPr lang="en-US" dirty="0" smtClean="0"/>
              <a:t> </a:t>
            </a:r>
            <a:r>
              <a:rPr lang="en-US" dirty="0"/>
              <a:t>alone</a:t>
            </a:r>
          </a:p>
        </p:txBody>
      </p:sp>
      <p:pic>
        <p:nvPicPr>
          <p:cNvPr id="5" name="Content Placeholder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330" y="327266"/>
            <a:ext cx="3200400" cy="32004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7271" y="327266"/>
            <a:ext cx="3200400" cy="3200400"/>
          </a:xfrm>
          <a:prstGeom prst="rect">
            <a:avLst/>
          </a:prstGeom>
        </p:spPr>
      </p:pic>
      <p:pic>
        <p:nvPicPr>
          <p:cNvPr id="7" name="Content Placeholder 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330" y="3890939"/>
            <a:ext cx="3200400" cy="3200400"/>
          </a:xfrm>
          <a:prstGeom prst="rect">
            <a:avLst/>
          </a:prstGeom>
        </p:spPr>
      </p:pic>
      <p:sp>
        <p:nvSpPr>
          <p:cNvPr id="8" name="Content Placeholder 2"/>
          <p:cNvSpPr txBox="1">
            <a:spLocks/>
          </p:cNvSpPr>
          <p:nvPr/>
        </p:nvSpPr>
        <p:spPr>
          <a:xfrm>
            <a:off x="1517501" y="3550285"/>
            <a:ext cx="5915025" cy="66463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 smtClean="0"/>
              <a:t>Donor R21-1054 </a:t>
            </a:r>
            <a:r>
              <a:rPr lang="en-US" dirty="0" err="1" smtClean="0"/>
              <a:t>pBMAds</a:t>
            </a:r>
            <a:r>
              <a:rPr lang="en-US" dirty="0" smtClean="0"/>
              <a:t> plus RPMI8226</a:t>
            </a:r>
            <a:endParaRPr lang="en-US" dirty="0"/>
          </a:p>
        </p:txBody>
      </p:sp>
      <p:pic>
        <p:nvPicPr>
          <p:cNvPr id="9" name="Content Placeholder 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7271" y="3872874"/>
            <a:ext cx="3200400" cy="3200400"/>
          </a:xfrm>
          <a:prstGeom prst="rect">
            <a:avLst/>
          </a:prstGeom>
        </p:spPr>
      </p:pic>
      <p:sp>
        <p:nvSpPr>
          <p:cNvPr id="12" name="Rectangle 11"/>
          <p:cNvSpPr/>
          <p:nvPr/>
        </p:nvSpPr>
        <p:spPr>
          <a:xfrm>
            <a:off x="-1112" y="-62258"/>
            <a:ext cx="142038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 smtClean="0">
                <a:latin typeface="+mj-lt"/>
              </a:rPr>
              <a:t>Supp</a:t>
            </a:r>
            <a:r>
              <a:rPr lang="en-US" b="1" dirty="0" smtClean="0">
                <a:latin typeface="+mj-lt"/>
              </a:rPr>
              <a:t> Figure 3</a:t>
            </a:r>
            <a:endParaRPr lang="en-US" b="1" dirty="0">
              <a:latin typeface="+mj-lt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2505075" y="3187223"/>
            <a:ext cx="571500" cy="1143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/>
          <p:cNvSpPr/>
          <p:nvPr/>
        </p:nvSpPr>
        <p:spPr>
          <a:xfrm>
            <a:off x="5957887" y="3187223"/>
            <a:ext cx="571500" cy="1143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/>
          <p:cNvSpPr/>
          <p:nvPr/>
        </p:nvSpPr>
        <p:spPr>
          <a:xfrm>
            <a:off x="5946774" y="6740048"/>
            <a:ext cx="571500" cy="1143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/>
          <p:cNvSpPr/>
          <p:nvPr/>
        </p:nvSpPr>
        <p:spPr>
          <a:xfrm>
            <a:off x="2505075" y="6740048"/>
            <a:ext cx="571500" cy="1143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Rectangle 3"/>
          <p:cNvSpPr/>
          <p:nvPr/>
        </p:nvSpPr>
        <p:spPr>
          <a:xfrm>
            <a:off x="55165" y="6835676"/>
            <a:ext cx="6747670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US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 3</a:t>
            </a:r>
            <a:r>
              <a:rPr lang="en-US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Imaging </a:t>
            </a:r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 coverslips of </a:t>
            </a:r>
            <a:r>
              <a:rPr lang="en-US" b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BMAds</a:t>
            </a:r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lone or with RPMI-8226 MM cells. </a:t>
            </a:r>
            <a:r>
              <a:rPr lang="en-US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BMAds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ere cultured on coverslips for 7 days and then RPMI-8226 were added for another 3 days (bottom images) or </a:t>
            </a:r>
            <a:r>
              <a:rPr lang="en-US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BMAds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ere cultured alone (top images). Images are overlays of confocal channels for </a:t>
            </a:r>
            <a:r>
              <a:rPr lang="en-US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halloidin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green) and Oil Red O (red). </a:t>
            </a:r>
            <a:r>
              <a:rPr lang="en-US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BMAds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ere seen in all samples, </a:t>
            </a:r>
            <a:r>
              <a:rPr lang="en-US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in the bottom right image, stromal cells (green only) could be seen.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cale bar = 200 µm.</a:t>
            </a:r>
            <a:endParaRPr lang="en-US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7262731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4916" y="6492783"/>
            <a:ext cx="2651760" cy="265176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1991876" y="65853"/>
            <a:ext cx="26236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err="1" smtClean="0"/>
              <a:t>pBMAds</a:t>
            </a:r>
            <a:r>
              <a:rPr lang="en-US" dirty="0" smtClean="0"/>
              <a:t> alone on scaffold</a:t>
            </a:r>
            <a:endParaRPr lang="en-US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0745" y="3393462"/>
            <a:ext cx="2651760" cy="2651760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2385307" y="3083670"/>
            <a:ext cx="293945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err="1" smtClean="0"/>
              <a:t>pBMAds</a:t>
            </a:r>
            <a:r>
              <a:rPr lang="en-US" dirty="0" smtClean="0"/>
              <a:t> + MM1S  on scaffold</a:t>
            </a:r>
            <a:endParaRPr lang="en-US" dirty="0"/>
          </a:p>
        </p:txBody>
      </p:sp>
      <p:pic>
        <p:nvPicPr>
          <p:cNvPr id="8" name="Content Placeholder 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0745" y="6480030"/>
            <a:ext cx="2651760" cy="2651760"/>
          </a:xfrm>
          <a:prstGeom prst="rect">
            <a:avLst/>
          </a:prstGeom>
        </p:spPr>
      </p:pic>
      <p:pic>
        <p:nvPicPr>
          <p:cNvPr id="9" name="Content Placeholder 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0745" y="377473"/>
            <a:ext cx="2651760" cy="2651760"/>
          </a:xfrm>
          <a:prstGeom prst="rect">
            <a:avLst/>
          </a:prstGeom>
        </p:spPr>
      </p:pic>
      <p:sp>
        <p:nvSpPr>
          <p:cNvPr id="11" name="Rectangle 10"/>
          <p:cNvSpPr/>
          <p:nvPr/>
        </p:nvSpPr>
        <p:spPr>
          <a:xfrm>
            <a:off x="2292144" y="6179164"/>
            <a:ext cx="250504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MM1S alone on scaffold</a:t>
            </a:r>
            <a:endParaRPr lang="en-US" dirty="0"/>
          </a:p>
        </p:txBody>
      </p:sp>
      <p:sp>
        <p:nvSpPr>
          <p:cNvPr id="12" name="Right Arrow 11"/>
          <p:cNvSpPr/>
          <p:nvPr/>
        </p:nvSpPr>
        <p:spPr>
          <a:xfrm rot="9144162">
            <a:off x="895778" y="6768382"/>
            <a:ext cx="487680" cy="259080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ight Arrow 12"/>
          <p:cNvSpPr/>
          <p:nvPr/>
        </p:nvSpPr>
        <p:spPr>
          <a:xfrm rot="7892341">
            <a:off x="1921443" y="4130660"/>
            <a:ext cx="487680" cy="259080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ight Arrow 13"/>
          <p:cNvSpPr/>
          <p:nvPr/>
        </p:nvSpPr>
        <p:spPr>
          <a:xfrm rot="5400000">
            <a:off x="602650" y="5375296"/>
            <a:ext cx="487680" cy="259080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ight Arrow 15"/>
          <p:cNvSpPr/>
          <p:nvPr/>
        </p:nvSpPr>
        <p:spPr>
          <a:xfrm rot="9144162">
            <a:off x="2324412" y="6640605"/>
            <a:ext cx="487680" cy="259080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4916" y="406492"/>
            <a:ext cx="2651760" cy="265176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4916" y="3409606"/>
            <a:ext cx="2651760" cy="2651760"/>
          </a:xfrm>
          <a:prstGeom prst="rect">
            <a:avLst/>
          </a:prstGeom>
        </p:spPr>
      </p:pic>
      <p:sp>
        <p:nvSpPr>
          <p:cNvPr id="20" name="Right Arrow 19"/>
          <p:cNvSpPr/>
          <p:nvPr/>
        </p:nvSpPr>
        <p:spPr>
          <a:xfrm rot="9144162">
            <a:off x="3860853" y="7221516"/>
            <a:ext cx="487680" cy="259080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ight Arrow 20"/>
          <p:cNvSpPr/>
          <p:nvPr/>
        </p:nvSpPr>
        <p:spPr>
          <a:xfrm rot="9144162">
            <a:off x="5148633" y="8227356"/>
            <a:ext cx="487680" cy="259080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/>
          <p:cNvSpPr/>
          <p:nvPr/>
        </p:nvSpPr>
        <p:spPr>
          <a:xfrm>
            <a:off x="-1112" y="-62258"/>
            <a:ext cx="142038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 smtClean="0">
                <a:latin typeface="+mj-lt"/>
              </a:rPr>
              <a:t>Supp</a:t>
            </a:r>
            <a:r>
              <a:rPr lang="en-US" b="1" dirty="0" smtClean="0">
                <a:latin typeface="+mj-lt"/>
              </a:rPr>
              <a:t> Figure 4</a:t>
            </a:r>
            <a:endParaRPr lang="en-US" b="1" dirty="0">
              <a:latin typeface="+mj-lt"/>
            </a:endParaRPr>
          </a:p>
        </p:txBody>
      </p:sp>
      <p:sp>
        <p:nvSpPr>
          <p:cNvPr id="22" name="Right Arrow 21"/>
          <p:cNvSpPr/>
          <p:nvPr/>
        </p:nvSpPr>
        <p:spPr>
          <a:xfrm rot="6190439">
            <a:off x="4189999" y="3527903"/>
            <a:ext cx="487680" cy="259080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ight Arrow 22"/>
          <p:cNvSpPr/>
          <p:nvPr/>
        </p:nvSpPr>
        <p:spPr>
          <a:xfrm rot="7892341">
            <a:off x="5754177" y="3881035"/>
            <a:ext cx="487680" cy="259080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/>
          <p:cNvSpPr/>
          <p:nvPr/>
        </p:nvSpPr>
        <p:spPr>
          <a:xfrm>
            <a:off x="2508250" y="5836886"/>
            <a:ext cx="479425" cy="816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/>
          <p:cNvSpPr/>
          <p:nvPr/>
        </p:nvSpPr>
        <p:spPr>
          <a:xfrm>
            <a:off x="5543550" y="5836886"/>
            <a:ext cx="479425" cy="816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/>
          <p:cNvSpPr/>
          <p:nvPr/>
        </p:nvSpPr>
        <p:spPr>
          <a:xfrm>
            <a:off x="2508250" y="8923624"/>
            <a:ext cx="479425" cy="816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/>
          <p:cNvSpPr/>
          <p:nvPr/>
        </p:nvSpPr>
        <p:spPr>
          <a:xfrm>
            <a:off x="5543550" y="8923624"/>
            <a:ext cx="479425" cy="816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/>
          <p:cNvSpPr/>
          <p:nvPr/>
        </p:nvSpPr>
        <p:spPr>
          <a:xfrm>
            <a:off x="2508250" y="2820334"/>
            <a:ext cx="479425" cy="816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/>
          <p:cNvSpPr/>
          <p:nvPr/>
        </p:nvSpPr>
        <p:spPr>
          <a:xfrm>
            <a:off x="5543550" y="2820334"/>
            <a:ext cx="479425" cy="816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971805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00050" y="0"/>
            <a:ext cx="6046644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US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4. </a:t>
            </a:r>
            <a:r>
              <a:rPr lang="en-US" b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BMAds</a:t>
            </a:r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an be co-cultured with myeloma cells in 3D.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D </a:t>
            </a:r>
            <a:r>
              <a:rPr lang="en-US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BMAds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upport myeloma. </a:t>
            </a:r>
            <a:r>
              <a:rPr lang="en-US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BMAds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donor 1039 again on 3D scaffolds. Imaging of scaffolds with overlay of confocal channels for </a:t>
            </a:r>
            <a:r>
              <a:rPr lang="en-US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halloidin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green) and Oil Red O (red). Scaffold </a:t>
            </a:r>
            <a:r>
              <a:rPr lang="en-US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utofluorescence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ppears light green or purple. Tumor cells indicated with arrows. Scale bar = 200 µm.</a:t>
            </a:r>
            <a:endParaRPr lang="en-US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5981119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114300" y="3121025"/>
            <a:ext cx="6743700" cy="25853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defTabSz="914400">
              <a:defRPr/>
            </a:pPr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5.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ve </a:t>
            </a:r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BMAds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ultured on scaffolds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 MM.1S cells can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 quantified with </a:t>
            </a:r>
            <a:r>
              <a:rPr lang="en-US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Titer-Glo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Titer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o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CTG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reagent was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ed to adipocytes, myeloma cells (MM.1S), or the co-culture after 7 days of adherence for </a:t>
            </a:r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BMAs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72 hour of culture/co-culture. Relative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luciferase activity (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LU) was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asured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 a proxy for cell viability (ATP production). CTG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vity from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BMAds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rom three donors are quantified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re; green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r indicates signal from both MM.1S and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BMAd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; error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rs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E.M. of RLU from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ltiple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affolds (i.e. technical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licates, n=3-5). 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-1112" y="-62258"/>
            <a:ext cx="142038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 smtClean="0">
                <a:latin typeface="+mj-lt"/>
              </a:rPr>
              <a:t>Supp</a:t>
            </a:r>
            <a:r>
              <a:rPr lang="en-US" b="1" dirty="0" smtClean="0">
                <a:latin typeface="+mj-lt"/>
              </a:rPr>
              <a:t> Figure 5</a:t>
            </a:r>
            <a:endParaRPr lang="en-US" b="1" dirty="0">
              <a:latin typeface="+mj-lt"/>
            </a:endParaRPr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17031011"/>
              </p:ext>
            </p:extLst>
          </p:nvPr>
        </p:nvGraphicFramePr>
        <p:xfrm>
          <a:off x="774398" y="422275"/>
          <a:ext cx="5356225" cy="2698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48" name="Prism 9" r:id="rId3" imgW="5355938" imgH="2698634" progId="Prism9.Document">
                  <p:embed/>
                </p:oleObj>
              </mc:Choice>
              <mc:Fallback>
                <p:oleObj name="Prism 9" r:id="rId3" imgW="5355938" imgH="2698634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74398" y="422275"/>
                        <a:ext cx="5356225" cy="26987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95118331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-1112" y="388298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(A)</a:t>
            </a:r>
            <a:endParaRPr lang="en-US" b="1" dirty="0"/>
          </a:p>
        </p:txBody>
      </p:sp>
      <p:sp>
        <p:nvSpPr>
          <p:cNvPr id="13" name="Rectangle 12"/>
          <p:cNvSpPr/>
          <p:nvPr/>
        </p:nvSpPr>
        <p:spPr>
          <a:xfrm>
            <a:off x="-1112" y="-62258"/>
            <a:ext cx="142038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 smtClean="0">
                <a:latin typeface="+mj-lt"/>
              </a:rPr>
              <a:t>Supp</a:t>
            </a:r>
            <a:r>
              <a:rPr lang="en-US" b="1" dirty="0" smtClean="0">
                <a:latin typeface="+mj-lt"/>
              </a:rPr>
              <a:t> Figure 6</a:t>
            </a:r>
            <a:endParaRPr lang="en-US" b="1" dirty="0">
              <a:latin typeface="+mj-lt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772260" y="3394509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(B)</a:t>
            </a:r>
            <a:endParaRPr lang="en-US" b="1" dirty="0"/>
          </a:p>
        </p:txBody>
      </p:sp>
      <p:sp>
        <p:nvSpPr>
          <p:cNvPr id="2" name="Rectangle 1"/>
          <p:cNvSpPr/>
          <p:nvPr/>
        </p:nvSpPr>
        <p:spPr>
          <a:xfrm>
            <a:off x="27139" y="6243545"/>
            <a:ext cx="6682943" cy="28623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 </a:t>
            </a:r>
            <a:r>
              <a:rPr lang="en-US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6. </a:t>
            </a:r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ene expression of </a:t>
            </a:r>
            <a:r>
              <a:rPr lang="en-US" b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BMAds</a:t>
            </a:r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myeloma cells alone or in co-culture using </a:t>
            </a:r>
            <a:r>
              <a:rPr lang="en-US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6-well, 72-hour </a:t>
            </a:r>
            <a:r>
              <a:rPr lang="en-US" b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answell</a:t>
            </a:r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o-culture. </a:t>
            </a:r>
            <a:r>
              <a:rPr lang="en-US" i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ABP4, CXCL1, TGFB1</a:t>
            </a:r>
            <a:r>
              <a:rPr lang="en-US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A; </a:t>
            </a:r>
            <a:r>
              <a:rPr lang="en-US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=4 donors) of </a:t>
            </a:r>
            <a:r>
              <a:rPr lang="en-US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BMAds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lone and in co-culture with </a:t>
            </a:r>
            <a:r>
              <a:rPr lang="en-US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M.1S cells;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ignificance determined by </a:t>
            </a:r>
            <a:r>
              <a:rPr lang="en-US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udent’s t-test (ns= not significant)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) Gene expression of glucocorticoid receptor cycling genes </a:t>
            </a:r>
            <a:r>
              <a:rPr lang="en-US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SC22D3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KBP5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M cells alone and in co-culture with </a:t>
            </a:r>
            <a:r>
              <a:rPr lang="en-US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BMAds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=4 individual experiments/response to 4 donors). Gene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pression (expressed as 2^-</a:t>
            </a:r>
            <a:r>
              <a:rPr lang="en-US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dct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values (gene of interest normalized to </a:t>
            </a:r>
            <a:r>
              <a:rPr lang="en-US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TB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ousekeeping</a:t>
            </a:r>
            <a:r>
              <a:rPr lang="en-US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),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ignificance (</a:t>
            </a:r>
            <a:r>
              <a:rPr lang="en-US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.s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) investigated by t-test</a:t>
            </a:r>
            <a:r>
              <a:rPr lang="en-US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rror bars represent S.E.M.</a:t>
            </a:r>
            <a:endParaRPr lang="en-US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01196071"/>
              </p:ext>
            </p:extLst>
          </p:nvPr>
        </p:nvGraphicFramePr>
        <p:xfrm>
          <a:off x="544440" y="307074"/>
          <a:ext cx="1955800" cy="3176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48" name="Prism 7" r:id="rId4" imgW="1955897" imgH="3175838" progId="Prism7.Document">
                  <p:embed/>
                </p:oleObj>
              </mc:Choice>
              <mc:Fallback>
                <p:oleObj name="Prism 7" r:id="rId4" imgW="1955897" imgH="3175838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44440" y="307074"/>
                        <a:ext cx="1955800" cy="3176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90439716"/>
              </p:ext>
            </p:extLst>
          </p:nvPr>
        </p:nvGraphicFramePr>
        <p:xfrm>
          <a:off x="4232014" y="321645"/>
          <a:ext cx="1946275" cy="3176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49" name="Prism 7" r:id="rId6" imgW="1946894" imgH="3175838" progId="Prism7.Document">
                  <p:embed/>
                </p:oleObj>
              </mc:Choice>
              <mc:Fallback>
                <p:oleObj name="Prism 7" r:id="rId6" imgW="1946894" imgH="3175838" progId="Prism7.Document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232014" y="321645"/>
                        <a:ext cx="1946275" cy="3176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70109765"/>
              </p:ext>
            </p:extLst>
          </p:nvPr>
        </p:nvGraphicFramePr>
        <p:xfrm>
          <a:off x="2390869" y="307074"/>
          <a:ext cx="1878013" cy="3176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50" name="Prism 7" r:id="rId8" imgW="1878108" imgH="3175838" progId="Prism7.Document">
                  <p:embed/>
                </p:oleObj>
              </mc:Choice>
              <mc:Fallback>
                <p:oleObj name="Prism 7" r:id="rId8" imgW="1878108" imgH="3175838" progId="Prism7.Document">
                  <p:embed/>
                  <p:pic>
                    <p:nvPicPr>
                      <p:cNvPr id="12" name="Object 11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390869" y="307074"/>
                        <a:ext cx="1878013" cy="3176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17948456"/>
              </p:ext>
            </p:extLst>
          </p:nvPr>
        </p:nvGraphicFramePr>
        <p:xfrm>
          <a:off x="1522340" y="3365986"/>
          <a:ext cx="1879674" cy="2743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51" name="Prism 9" r:id="rId10" imgW="2228880" imgH="3252191" progId="Prism9.Document">
                  <p:embed/>
                </p:oleObj>
              </mc:Choice>
              <mc:Fallback>
                <p:oleObj name="Prism 9" r:id="rId10" imgW="2228880" imgH="3252191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1522340" y="3365986"/>
                        <a:ext cx="1879674" cy="2743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34725567"/>
              </p:ext>
            </p:extLst>
          </p:nvPr>
        </p:nvGraphicFramePr>
        <p:xfrm>
          <a:off x="3471725" y="3365986"/>
          <a:ext cx="1947368" cy="2743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52" name="Prism 9" r:id="rId12" imgW="2233562" imgH="3147026" progId="Prism9.Document">
                  <p:embed/>
                </p:oleObj>
              </mc:Choice>
              <mc:Fallback>
                <p:oleObj name="Prism 9" r:id="rId12" imgW="2233562" imgH="3147026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471725" y="3365986"/>
                        <a:ext cx="1947368" cy="2743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8759199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59444919"/>
              </p:ext>
            </p:extLst>
          </p:nvPr>
        </p:nvGraphicFramePr>
        <p:xfrm>
          <a:off x="329712" y="-11059"/>
          <a:ext cx="6232915" cy="2978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63" name="Prism 7" r:id="rId4" imgW="5342253" imgH="2552412" progId="Prism7.Document">
                  <p:embed/>
                </p:oleObj>
              </mc:Choice>
              <mc:Fallback>
                <p:oleObj name="Prism 7" r:id="rId4" imgW="5342253" imgH="2552412" progId="Prism7.Document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29712" y="-11059"/>
                        <a:ext cx="6232915" cy="2978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Oval 4"/>
          <p:cNvSpPr/>
          <p:nvPr/>
        </p:nvSpPr>
        <p:spPr>
          <a:xfrm rot="915990">
            <a:off x="1221208" y="537465"/>
            <a:ext cx="1131274" cy="627784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sp>
        <p:nvSpPr>
          <p:cNvPr id="6" name="Oval 5"/>
          <p:cNvSpPr/>
          <p:nvPr/>
        </p:nvSpPr>
        <p:spPr>
          <a:xfrm rot="5400000">
            <a:off x="2374196" y="790172"/>
            <a:ext cx="553915" cy="471962"/>
          </a:xfrm>
          <a:prstGeom prst="ellipse">
            <a:avLst/>
          </a:prstGeom>
          <a:noFill/>
          <a:ln w="38100"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sp>
        <p:nvSpPr>
          <p:cNvPr id="7" name="Oval 6"/>
          <p:cNvSpPr/>
          <p:nvPr/>
        </p:nvSpPr>
        <p:spPr>
          <a:xfrm rot="5400000">
            <a:off x="3281553" y="688175"/>
            <a:ext cx="519097" cy="883626"/>
          </a:xfrm>
          <a:prstGeom prst="ellipse">
            <a:avLst/>
          </a:prstGeom>
          <a:noFill/>
          <a:ln w="3810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sp>
        <p:nvSpPr>
          <p:cNvPr id="8" name="TextBox 7"/>
          <p:cNvSpPr txBox="1"/>
          <p:nvPr/>
        </p:nvSpPr>
        <p:spPr>
          <a:xfrm>
            <a:off x="164612" y="388327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A)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2580"/>
          <a:stretch/>
        </p:blipFill>
        <p:spPr>
          <a:xfrm>
            <a:off x="458863" y="2968646"/>
            <a:ext cx="3797634" cy="3676021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229473" y="3020527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B)</a:t>
            </a:r>
            <a:endParaRPr lang="en-US" dirty="0"/>
          </a:p>
        </p:txBody>
      </p:sp>
      <p:sp>
        <p:nvSpPr>
          <p:cNvPr id="11" name="Rectangle 10"/>
          <p:cNvSpPr/>
          <p:nvPr/>
        </p:nvSpPr>
        <p:spPr>
          <a:xfrm>
            <a:off x="-1112" y="-62258"/>
            <a:ext cx="142038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 smtClean="0">
                <a:latin typeface="+mj-lt"/>
              </a:rPr>
              <a:t>Supp</a:t>
            </a:r>
            <a:r>
              <a:rPr lang="en-US" b="1" dirty="0" smtClean="0">
                <a:latin typeface="+mj-lt"/>
              </a:rPr>
              <a:t> Figure 7</a:t>
            </a:r>
            <a:endParaRPr lang="en-US" b="1" dirty="0">
              <a:latin typeface="+mj-lt"/>
            </a:endParaRP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3985"/>
          <a:stretch/>
        </p:blipFill>
        <p:spPr>
          <a:xfrm>
            <a:off x="3541101" y="3311894"/>
            <a:ext cx="3797634" cy="327953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-24471" y="6644667"/>
            <a:ext cx="6882471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7. Mass spectrometry proteomic analysis of conditioned media samples from </a:t>
            </a:r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BMAds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myeloma cells alone and in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-culture in 2D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A (principal component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alysis)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vealed differential protein expression between sample types (A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atmap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the 16 proteins differentially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ed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p&lt;0.05 as assessed by t-tests) between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groups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). (Log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rmalized expression values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e shown (Morpheus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software.broadinstitute.org/Morpheus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;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e minus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endall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rrelation was used to cluster samples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)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932765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39</TotalTime>
  <Words>804</Words>
  <Application>Microsoft Office PowerPoint</Application>
  <PresentationFormat>On-screen Show (4:3)</PresentationFormat>
  <Paragraphs>43</Paragraphs>
  <Slides>11</Slides>
  <Notes>6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1</vt:i4>
      </vt:variant>
    </vt:vector>
  </HeadingPairs>
  <TitlesOfParts>
    <vt:vector size="18" baseType="lpstr">
      <vt:lpstr>Arial</vt:lpstr>
      <vt:lpstr>Calibri</vt:lpstr>
      <vt:lpstr>Calibri Light</vt:lpstr>
      <vt:lpstr>Times New Roman</vt:lpstr>
      <vt:lpstr>Office Theme</vt:lpstr>
      <vt:lpstr>Prism 9</vt:lpstr>
      <vt:lpstr>Prism 7</vt:lpstr>
      <vt:lpstr>Supplemental Figure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aineHealt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Figures</dc:title>
  <dc:creator>Michaela R. Reagan</dc:creator>
  <cp:lastModifiedBy>Reagan, Michaela R</cp:lastModifiedBy>
  <cp:revision>65</cp:revision>
  <dcterms:created xsi:type="dcterms:W3CDTF">2022-03-24T19:42:15Z</dcterms:created>
  <dcterms:modified xsi:type="dcterms:W3CDTF">2022-11-08T18:56:10Z</dcterms:modified>
</cp:coreProperties>
</file>